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6" autoAdjust="0"/>
    <p:restoredTop sz="94660"/>
  </p:normalViewPr>
  <p:slideViewPr>
    <p:cSldViewPr snapToGrid="0">
      <p:cViewPr varScale="1">
        <p:scale>
          <a:sx n="48" d="100"/>
          <a:sy n="48" d="100"/>
        </p:scale>
        <p:origin x="2092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obert Schaffer" userId="30379af1-9b08-43f5-b0a6-5fbc9da7bcf5" providerId="ADAL" clId="{9A962718-3858-4AA5-AE88-65E12B3AE827}"/>
    <pc:docChg chg="delSld">
      <pc:chgData name="Robert Schaffer" userId="30379af1-9b08-43f5-b0a6-5fbc9da7bcf5" providerId="ADAL" clId="{9A962718-3858-4AA5-AE88-65E12B3AE827}" dt="2025-01-06T01:16:16.188" v="0" actId="47"/>
      <pc:docMkLst>
        <pc:docMk/>
      </pc:docMkLst>
      <pc:sldChg chg="del">
        <pc:chgData name="Robert Schaffer" userId="30379af1-9b08-43f5-b0a6-5fbc9da7bcf5" providerId="ADAL" clId="{9A962718-3858-4AA5-AE88-65E12B3AE827}" dt="2025-01-06T01:16:16.188" v="0" actId="47"/>
        <pc:sldMkLst>
          <pc:docMk/>
          <pc:sldMk cId="3609519590" sldId="256"/>
        </pc:sldMkLst>
      </pc:sldChg>
      <pc:sldChg chg="del">
        <pc:chgData name="Robert Schaffer" userId="30379af1-9b08-43f5-b0a6-5fbc9da7bcf5" providerId="ADAL" clId="{9A962718-3858-4AA5-AE88-65E12B3AE827}" dt="2025-01-06T01:16:16.188" v="0" actId="47"/>
        <pc:sldMkLst>
          <pc:docMk/>
          <pc:sldMk cId="349587037" sldId="266"/>
        </pc:sldMkLst>
      </pc:sldChg>
      <pc:sldChg chg="del">
        <pc:chgData name="Robert Schaffer" userId="30379af1-9b08-43f5-b0a6-5fbc9da7bcf5" providerId="ADAL" clId="{9A962718-3858-4AA5-AE88-65E12B3AE827}" dt="2025-01-06T01:16:16.188" v="0" actId="47"/>
        <pc:sldMkLst>
          <pc:docMk/>
          <pc:sldMk cId="93960508" sldId="267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mta-file\data\Fruit%20Genomics\Texture\Ling\MADS8ox%20Masters%20project%20files\MADS8%20Final%20cDN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mta-file\data\Fruit%20Genomics\Texture\Ling\MADS8ox%20Masters%20project%20files\MADS8%20Final%20cDNA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mta-file\data\Fruit%20Genomics\Texture\Ling\MADS8ox%20Masters%20project%20files\MADS8%20Final%20cDN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mta-file\data\Fruit%20Genomics\Texture\Ling\MADS8ox%20Masters%20project%20files\MADS8%20Final%20cDN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i="1" dirty="0">
                <a:solidFill>
                  <a:schemeClr val="tx1"/>
                </a:solidFill>
              </a:rPr>
              <a:t>MADS8</a:t>
            </a:r>
          </a:p>
        </c:rich>
      </c:tx>
      <c:layout>
        <c:manualLayout>
          <c:xMode val="edge"/>
          <c:yMode val="edge"/>
          <c:x val="0.44630361757105935"/>
          <c:y val="4.23333333333333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32750193798449612"/>
          <c:y val="0.18407944444444443"/>
          <c:w val="0.62560335917312659"/>
          <c:h val="0.523575000000000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ADS8!$L$68:$L$72</c:f>
                <c:numCache>
                  <c:formatCode>General</c:formatCode>
                  <c:ptCount val="5"/>
                  <c:pt idx="0">
                    <c:v>2.6425446290775619E-4</c:v>
                  </c:pt>
                  <c:pt idx="1">
                    <c:v>3.4469704895103987E-4</c:v>
                  </c:pt>
                  <c:pt idx="2">
                    <c:v>1.5747163765791815E-4</c:v>
                  </c:pt>
                  <c:pt idx="3">
                    <c:v>2.1878296805535644E-4</c:v>
                  </c:pt>
                  <c:pt idx="4">
                    <c:v>2.3749999999999997E-4</c:v>
                  </c:pt>
                </c:numCache>
              </c:numRef>
            </c:plus>
            <c:minus>
              <c:numRef>
                <c:f>MADS8!$L$68:$L$72</c:f>
                <c:numCache>
                  <c:formatCode>General</c:formatCode>
                  <c:ptCount val="5"/>
                  <c:pt idx="0">
                    <c:v>2.6425446290775619E-4</c:v>
                  </c:pt>
                  <c:pt idx="1">
                    <c:v>3.4469704895103987E-4</c:v>
                  </c:pt>
                  <c:pt idx="2">
                    <c:v>1.5747163765791815E-4</c:v>
                  </c:pt>
                  <c:pt idx="3">
                    <c:v>2.1878296805535644E-4</c:v>
                  </c:pt>
                  <c:pt idx="4">
                    <c:v>2.3749999999999997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ADS8!$J$68:$J$72</c:f>
              <c:strCache>
                <c:ptCount val="5"/>
                <c:pt idx="0">
                  <c:v>WT</c:v>
                </c:pt>
                <c:pt idx="1">
                  <c:v>A5</c:v>
                </c:pt>
                <c:pt idx="2">
                  <c:v>A6</c:v>
                </c:pt>
                <c:pt idx="3">
                  <c:v>A9</c:v>
                </c:pt>
                <c:pt idx="4">
                  <c:v>A11</c:v>
                </c:pt>
              </c:strCache>
            </c:strRef>
          </c:cat>
          <c:val>
            <c:numRef>
              <c:f>MADS8!$K$68:$K$72</c:f>
              <c:numCache>
                <c:formatCode>0.00E+00</c:formatCode>
                <c:ptCount val="5"/>
                <c:pt idx="0">
                  <c:v>5.8805000000000001E-4</c:v>
                </c:pt>
                <c:pt idx="1">
                  <c:v>1.0443333333333333E-3</c:v>
                </c:pt>
                <c:pt idx="2">
                  <c:v>6.2950000000000007E-4</c:v>
                </c:pt>
                <c:pt idx="3">
                  <c:v>5.4176666666666659E-4</c:v>
                </c:pt>
                <c:pt idx="4">
                  <c:v>7.025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F31-48FE-88CA-35E99D7C67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87105056"/>
        <c:axId val="687104496"/>
      </c:barChart>
      <c:catAx>
        <c:axId val="687105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87104496"/>
        <c:crosses val="autoZero"/>
        <c:auto val="1"/>
        <c:lblAlgn val="ctr"/>
        <c:lblOffset val="100"/>
        <c:noMultiLvlLbl val="0"/>
      </c:catAx>
      <c:valAx>
        <c:axId val="687104496"/>
        <c:scaling>
          <c:orientation val="minMax"/>
        </c:scaling>
        <c:delete val="0"/>
        <c:axPos val="l"/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87105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i="1"/>
            </a:pPr>
            <a:r>
              <a:rPr lang="en-NZ" sz="1100" b="0" i="1" dirty="0"/>
              <a:t>MADS8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3333268733850129"/>
          <c:y val="0.15897944444444442"/>
          <c:w val="0.67642183462532302"/>
          <c:h val="0.5670416666666666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cool beans'!$F$47:$F$51</c:f>
                <c:numCache>
                  <c:formatCode>General</c:formatCode>
                  <c:ptCount val="5"/>
                  <c:pt idx="0">
                    <c:v>1.0999999999999999E-2</c:v>
                  </c:pt>
                  <c:pt idx="1">
                    <c:v>2.3900000000000002E-3</c:v>
                  </c:pt>
                  <c:pt idx="2">
                    <c:v>2.98E-2</c:v>
                  </c:pt>
                  <c:pt idx="3">
                    <c:v>0.09</c:v>
                  </c:pt>
                  <c:pt idx="4">
                    <c:v>3.4099999999999998E-2</c:v>
                  </c:pt>
                </c:numCache>
              </c:numRef>
            </c:plus>
            <c:minus>
              <c:numRef>
                <c:f>'cool beans'!$F$47:$F$51</c:f>
                <c:numCache>
                  <c:formatCode>General</c:formatCode>
                  <c:ptCount val="5"/>
                  <c:pt idx="0">
                    <c:v>1.0999999999999999E-2</c:v>
                  </c:pt>
                  <c:pt idx="1">
                    <c:v>2.3900000000000002E-3</c:v>
                  </c:pt>
                  <c:pt idx="2">
                    <c:v>2.98E-2</c:v>
                  </c:pt>
                  <c:pt idx="3">
                    <c:v>0.09</c:v>
                  </c:pt>
                  <c:pt idx="4">
                    <c:v>3.4099999999999998E-2</c:v>
                  </c:pt>
                </c:numCache>
              </c:numRef>
            </c:minus>
          </c:errBars>
          <c:cat>
            <c:strRef>
              <c:f>'cool beans'!$C$47:$C$51</c:f>
              <c:strCache>
                <c:ptCount val="5"/>
                <c:pt idx="0">
                  <c:v>WT</c:v>
                </c:pt>
                <c:pt idx="1">
                  <c:v>A5</c:v>
                </c:pt>
                <c:pt idx="2">
                  <c:v>A6</c:v>
                </c:pt>
                <c:pt idx="3">
                  <c:v>A9</c:v>
                </c:pt>
                <c:pt idx="4">
                  <c:v>A11</c:v>
                </c:pt>
              </c:strCache>
            </c:strRef>
          </c:cat>
          <c:val>
            <c:numRef>
              <c:f>'cool beans'!$E$47:$E$51</c:f>
              <c:numCache>
                <c:formatCode>0.00E+00</c:formatCode>
                <c:ptCount val="5"/>
                <c:pt idx="0" formatCode="General">
                  <c:v>0.1898</c:v>
                </c:pt>
                <c:pt idx="1">
                  <c:v>1.7100000000000001E-2</c:v>
                </c:pt>
                <c:pt idx="2" formatCode="General">
                  <c:v>0.22819999999999999</c:v>
                </c:pt>
                <c:pt idx="3" formatCode="General">
                  <c:v>0.17960000000000001</c:v>
                </c:pt>
                <c:pt idx="4" formatCode="General">
                  <c:v>0.3788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9B-41AC-B31A-48A45490D5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87116816"/>
        <c:axId val="687118496"/>
      </c:barChart>
      <c:catAx>
        <c:axId val="68711681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 rot="-5400000" vert="horz"/>
          <a:lstStyle/>
          <a:p>
            <a:pPr>
              <a:defRPr sz="900"/>
            </a:pPr>
            <a:endParaRPr lang="de-DE"/>
          </a:p>
        </c:txPr>
        <c:crossAx val="687118496"/>
        <c:crosses val="autoZero"/>
        <c:auto val="1"/>
        <c:lblAlgn val="ctr"/>
        <c:lblOffset val="100"/>
        <c:noMultiLvlLbl val="0"/>
      </c:catAx>
      <c:valAx>
        <c:axId val="6871184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noFill/>
          </a:ln>
        </c:spPr>
        <c:txPr>
          <a:bodyPr/>
          <a:lstStyle/>
          <a:p>
            <a:pPr>
              <a:defRPr sz="900"/>
            </a:pPr>
            <a:endParaRPr lang="de-DE"/>
          </a:p>
        </c:txPr>
        <c:crossAx val="6871168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100" i="1" dirty="0">
                <a:solidFill>
                  <a:schemeClr val="tx1"/>
                </a:solidFill>
              </a:rPr>
              <a:t>ACS1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CS1'!$D$36:$D$41</c:f>
                <c:numCache>
                  <c:formatCode>General</c:formatCode>
                  <c:ptCount val="6"/>
                  <c:pt idx="0">
                    <c:v>1.0397737467566807E-2</c:v>
                  </c:pt>
                  <c:pt idx="1">
                    <c:v>7.6635682144662268E-3</c:v>
                  </c:pt>
                  <c:pt idx="2">
                    <c:v>2.2990688936562621E-2</c:v>
                  </c:pt>
                  <c:pt idx="3">
                    <c:v>1.1349008767288938E-2</c:v>
                  </c:pt>
                  <c:pt idx="4">
                    <c:v>4.2500000000000107E-2</c:v>
                  </c:pt>
                  <c:pt idx="5">
                    <c:v>6.0489484852970753E-3</c:v>
                  </c:pt>
                </c:numCache>
              </c:numRef>
            </c:plus>
            <c:minus>
              <c:numRef>
                <c:f>'ACS1'!$D$36:$D$41</c:f>
                <c:numCache>
                  <c:formatCode>General</c:formatCode>
                  <c:ptCount val="6"/>
                  <c:pt idx="0">
                    <c:v>1.0397737467566807E-2</c:v>
                  </c:pt>
                  <c:pt idx="1">
                    <c:v>7.6635682144662268E-3</c:v>
                  </c:pt>
                  <c:pt idx="2">
                    <c:v>2.2990688936562621E-2</c:v>
                  </c:pt>
                  <c:pt idx="3">
                    <c:v>1.1349008767288938E-2</c:v>
                  </c:pt>
                  <c:pt idx="4">
                    <c:v>4.2500000000000107E-2</c:v>
                  </c:pt>
                  <c:pt idx="5">
                    <c:v>6.048948485297075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CS1'!$B$36:$B$41</c:f>
              <c:strCache>
                <c:ptCount val="6"/>
                <c:pt idx="0">
                  <c:v>WT</c:v>
                </c:pt>
                <c:pt idx="1">
                  <c:v>A5</c:v>
                </c:pt>
                <c:pt idx="2">
                  <c:v>A6</c:v>
                </c:pt>
                <c:pt idx="3">
                  <c:v>A9</c:v>
                </c:pt>
                <c:pt idx="4">
                  <c:v>A11</c:v>
                </c:pt>
                <c:pt idx="5">
                  <c:v>MADS8as</c:v>
                </c:pt>
              </c:strCache>
            </c:strRef>
          </c:cat>
          <c:val>
            <c:numRef>
              <c:f>'ACS1'!$C$36:$C$41</c:f>
              <c:numCache>
                <c:formatCode>General</c:formatCode>
                <c:ptCount val="6"/>
                <c:pt idx="0">
                  <c:v>0.23523333333333332</c:v>
                </c:pt>
                <c:pt idx="1">
                  <c:v>0.15181666666666668</c:v>
                </c:pt>
                <c:pt idx="2">
                  <c:v>0.38806666666666662</c:v>
                </c:pt>
                <c:pt idx="3">
                  <c:v>0.16439999999999999</c:v>
                </c:pt>
                <c:pt idx="4">
                  <c:v>0.37919999999999998</c:v>
                </c:pt>
                <c:pt idx="5">
                  <c:v>0.1544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D97-4A6C-B143-47AC705673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6219472"/>
        <c:axId val="346214432"/>
      </c:barChart>
      <c:catAx>
        <c:axId val="346219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6214432"/>
        <c:crosses val="autoZero"/>
        <c:auto val="1"/>
        <c:lblAlgn val="ctr"/>
        <c:lblOffset val="100"/>
        <c:noMultiLvlLbl val="0"/>
      </c:catAx>
      <c:valAx>
        <c:axId val="34621443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62194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100" i="1">
                <a:solidFill>
                  <a:sysClr val="windowText" lastClr="000000"/>
                </a:solidFill>
              </a:rPr>
              <a:t>ACO1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CO1'!$D$36:$D$41</c:f>
                <c:numCache>
                  <c:formatCode>General</c:formatCode>
                  <c:ptCount val="6"/>
                  <c:pt idx="0">
                    <c:v>5.5678394473180598E-2</c:v>
                  </c:pt>
                  <c:pt idx="1">
                    <c:v>4.6429634334597687E-2</c:v>
                  </c:pt>
                  <c:pt idx="2">
                    <c:v>0.10576016814787437</c:v>
                  </c:pt>
                  <c:pt idx="3">
                    <c:v>2.0970589193227571E-2</c:v>
                  </c:pt>
                  <c:pt idx="4">
                    <c:v>0.11359999999999984</c:v>
                  </c:pt>
                  <c:pt idx="5">
                    <c:v>1.6072122171982006E-2</c:v>
                  </c:pt>
                </c:numCache>
              </c:numRef>
            </c:plus>
            <c:minus>
              <c:numRef>
                <c:f>'ACO1'!$D$36:$D$41</c:f>
                <c:numCache>
                  <c:formatCode>General</c:formatCode>
                  <c:ptCount val="6"/>
                  <c:pt idx="0">
                    <c:v>5.5678394473180598E-2</c:v>
                  </c:pt>
                  <c:pt idx="1">
                    <c:v>4.6429634334597687E-2</c:v>
                  </c:pt>
                  <c:pt idx="2">
                    <c:v>0.10576016814787437</c:v>
                  </c:pt>
                  <c:pt idx="3">
                    <c:v>2.0970589193227571E-2</c:v>
                  </c:pt>
                  <c:pt idx="4">
                    <c:v>0.11359999999999984</c:v>
                  </c:pt>
                  <c:pt idx="5">
                    <c:v>1.607212217198200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CO1'!$B$36:$B$41</c:f>
              <c:strCache>
                <c:ptCount val="6"/>
                <c:pt idx="0">
                  <c:v>WT</c:v>
                </c:pt>
                <c:pt idx="1">
                  <c:v>A5</c:v>
                </c:pt>
                <c:pt idx="2">
                  <c:v>A6</c:v>
                </c:pt>
                <c:pt idx="3">
                  <c:v>A9</c:v>
                </c:pt>
                <c:pt idx="4">
                  <c:v>A11</c:v>
                </c:pt>
                <c:pt idx="5">
                  <c:v>MADS8as</c:v>
                </c:pt>
              </c:strCache>
            </c:strRef>
          </c:cat>
          <c:val>
            <c:numRef>
              <c:f>'ACO1'!$C$36:$C$41</c:f>
              <c:numCache>
                <c:formatCode>General</c:formatCode>
                <c:ptCount val="6"/>
                <c:pt idx="0">
                  <c:v>0.29361666666666669</c:v>
                </c:pt>
                <c:pt idx="1">
                  <c:v>0.30518333333333331</c:v>
                </c:pt>
                <c:pt idx="2">
                  <c:v>0.70435000000000014</c:v>
                </c:pt>
                <c:pt idx="3">
                  <c:v>0.2527833333333333</c:v>
                </c:pt>
                <c:pt idx="4">
                  <c:v>0.51360000000000006</c:v>
                </c:pt>
                <c:pt idx="5">
                  <c:v>0.215366666666666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C1F-4E52-A0CF-320B211E9D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6208272"/>
        <c:axId val="346212752"/>
      </c:barChart>
      <c:catAx>
        <c:axId val="346208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6212752"/>
        <c:crosses val="autoZero"/>
        <c:auto val="1"/>
        <c:lblAlgn val="ctr"/>
        <c:lblOffset val="100"/>
        <c:noMultiLvlLbl val="0"/>
      </c:catAx>
      <c:valAx>
        <c:axId val="34621275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6208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66593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778704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74208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71107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795874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44812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35045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95551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01934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716858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02258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A3040C-E8D8-42A4-9385-AAC41F3E4D26}" type="datetimeFigureOut">
              <a:rPr lang="en-NZ" smtClean="0"/>
              <a:t>22/01/2025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557D09-0A50-4258-A525-5FFCA9EF0303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835736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444500" y="4489007"/>
            <a:ext cx="6032092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 profiles of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DS8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pening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S1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O1</a:t>
            </a:r>
            <a:r>
              <a:rPr lang="en-US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wild-type and transgenic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DS8ox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DS8a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s from fruit flesh tissues. Fruit tissues were taken at 80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F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186 DAFB 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Expression values are relative to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Values are averages +/- SE 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4). </a:t>
            </a:r>
            <a:endParaRPr lang="en-NZ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 rot="16200000">
            <a:off x="-254410" y="3237394"/>
            <a:ext cx="11208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 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-254409" y="1428624"/>
            <a:ext cx="11208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 </a:t>
            </a:r>
          </a:p>
        </p:txBody>
      </p:sp>
      <p:graphicFrame>
        <p:nvGraphicFramePr>
          <p:cNvPr id="8" name="Chart 7"/>
          <p:cNvGraphicFramePr>
            <a:graphicFrameLocks/>
          </p:cNvGraphicFramePr>
          <p:nvPr/>
        </p:nvGraphicFramePr>
        <p:xfrm>
          <a:off x="1812861" y="889006"/>
          <a:ext cx="1548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/>
        </p:nvGraphicFramePr>
        <p:xfrm>
          <a:off x="529020" y="856546"/>
          <a:ext cx="136836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43131" y="725741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897380" y="725741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43131" y="2390487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897380" y="2390487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graphicFrame>
        <p:nvGraphicFramePr>
          <p:cNvPr id="14" name="Chart 13"/>
          <p:cNvGraphicFramePr>
            <a:graphicFrameLocks/>
          </p:cNvGraphicFramePr>
          <p:nvPr/>
        </p:nvGraphicFramePr>
        <p:xfrm>
          <a:off x="529019" y="2510376"/>
          <a:ext cx="1368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/>
        </p:nvGraphicFramePr>
        <p:xfrm>
          <a:off x="2061000" y="2517098"/>
          <a:ext cx="1368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090110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0</Words>
  <Application>Microsoft Office PowerPoint</Application>
  <PresentationFormat>A4-Papier (210 x 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>Plant &amp; Food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Schaffer</dc:creator>
  <cp:lastModifiedBy>Brigitte</cp:lastModifiedBy>
  <cp:revision>9</cp:revision>
  <dcterms:created xsi:type="dcterms:W3CDTF">2021-10-18T00:31:37Z</dcterms:created>
  <dcterms:modified xsi:type="dcterms:W3CDTF">2025-01-22T11:45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d8f3512-c98a-4fbc-ad6e-3260f1cde3f8_Enabled">
    <vt:lpwstr>true</vt:lpwstr>
  </property>
  <property fmtid="{D5CDD505-2E9C-101B-9397-08002B2CF9AE}" pid="3" name="MSIP_Label_8d8f3512-c98a-4fbc-ad6e-3260f1cde3f8_SetDate">
    <vt:lpwstr>2024-10-21T22:09:08Z</vt:lpwstr>
  </property>
  <property fmtid="{D5CDD505-2E9C-101B-9397-08002B2CF9AE}" pid="4" name="MSIP_Label_8d8f3512-c98a-4fbc-ad6e-3260f1cde3f8_Method">
    <vt:lpwstr>Standard</vt:lpwstr>
  </property>
  <property fmtid="{D5CDD505-2E9C-101B-9397-08002B2CF9AE}" pid="5" name="MSIP_Label_8d8f3512-c98a-4fbc-ad6e-3260f1cde3f8_Name">
    <vt:lpwstr>Internal</vt:lpwstr>
  </property>
  <property fmtid="{D5CDD505-2E9C-101B-9397-08002B2CF9AE}" pid="6" name="MSIP_Label_8d8f3512-c98a-4fbc-ad6e-3260f1cde3f8_SiteId">
    <vt:lpwstr>6ca75ef7-2c66-42e7-af2c-6502153a7e3a</vt:lpwstr>
  </property>
  <property fmtid="{D5CDD505-2E9C-101B-9397-08002B2CF9AE}" pid="7" name="MSIP_Label_8d8f3512-c98a-4fbc-ad6e-3260f1cde3f8_ActionId">
    <vt:lpwstr>914ec625-308d-4b51-bd43-6d1de01e539d</vt:lpwstr>
  </property>
  <property fmtid="{D5CDD505-2E9C-101B-9397-08002B2CF9AE}" pid="8" name="MSIP_Label_8d8f3512-c98a-4fbc-ad6e-3260f1cde3f8_ContentBits">
    <vt:lpwstr>0</vt:lpwstr>
  </property>
</Properties>
</file>